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25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108" y="6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B987C4-CE03-7A94-8AC9-171E7A5D29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E9C6BB4-727C-21DA-F1AC-404BA94A13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6D6807-35B7-9F90-FB1A-EEBAB6367C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85B51-CDF6-44DB-A5B5-27361F306A01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C12574-E7A5-2079-9969-06539C6D4F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BE4E43-3173-25B6-7D31-700E7C3406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C5EB-E99E-48E7-806C-566BBE26CF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4753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95401B-0963-B5D4-5CB7-79E9D67F87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4A1CC6-3B05-BD7D-AEF0-20519531A1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B182F1-5A4E-96B8-FB5A-22B0912CFD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85B51-CDF6-44DB-A5B5-27361F306A01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0561F2-B974-7D62-ADA1-F00DC82F30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0F06A2-C9EA-BE95-2E09-4E2A6F5F1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C5EB-E99E-48E7-806C-566BBE26CF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4538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1C1F057-8432-8FB5-6C32-1B575E8089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DCC14A-1C5C-6A14-B447-A242E69608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3571A1-67C8-3FFF-0EC3-6E869D35EA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85B51-CDF6-44DB-A5B5-27361F306A01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C2E35E-7C90-DABE-E602-375447871D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7F1580-A310-2A16-3009-2D49B2077B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C5EB-E99E-48E7-806C-566BBE26CF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493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4A037B-F853-BFAE-4005-E2904DED7D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81AA7B-E91F-2EE2-8907-A8E137A668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1B3DCF-E3F7-20F5-B416-2CE016BABA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85B51-CDF6-44DB-A5B5-27361F306A01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1DCA87-1B46-9A4F-6868-A8B0266121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7BE37E-85DE-456D-18B5-A2E15D7E1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C5EB-E99E-48E7-806C-566BBE26CF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003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F77222-50A2-0EC0-D5F3-143F107F16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7A3BC2-229E-8A3C-F2EE-F01D94B8A6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78797E-070B-9544-70AF-6580B14FD5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85B51-CDF6-44DB-A5B5-27361F306A01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1B8114-05EF-1121-756A-B1CA3164FC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0D2141-BF76-25E9-16D5-A70D5A8E33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C5EB-E99E-48E7-806C-566BBE26CF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130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85117E-8829-8207-172C-31FB559DDD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901E03-A09E-FECA-4CFE-F0B23F603F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7335F47-2F9B-84CF-CD38-1A7F6F1DD4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6741C7-B845-A667-4775-B213A11021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85B51-CDF6-44DB-A5B5-27361F306A01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F67015-07A3-B80C-285C-B8C06CEE6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F57596-5048-2F3E-4E94-FAD4AB8C6A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C5EB-E99E-48E7-806C-566BBE26CF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00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E7D985-1A5B-23E1-A204-97EED21A4B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F2F435-F1A7-3AC3-7269-D43B37BF36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C3405F-337A-05DF-6F00-D892841779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A79EDDF-8CEB-6413-1BC8-1677CD8B10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DB9E2F1-192C-DEB6-FD87-CF002D9155F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F36886E-C532-96A5-D3BD-957D67E924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85B51-CDF6-44DB-A5B5-27361F306A01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2D09171-E26C-6372-109C-F79017EB96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92021F4-F8D0-3655-81D6-7D868429D5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C5EB-E99E-48E7-806C-566BBE26CF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048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91E8E2-FE63-41E7-9B8B-0462F02D38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D01245C-3D8A-E0EB-95CB-5AA446D1CB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85B51-CDF6-44DB-A5B5-27361F306A01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3F256D2-7D36-B262-69AA-F758B6BC57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B7B8282-EB8C-F211-79CD-C59A3E398F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C5EB-E99E-48E7-806C-566BBE26CF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4290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15764D3-BB24-852E-5C29-A54DBC01A8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85B51-CDF6-44DB-A5B5-27361F306A01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1508320-965F-143B-A90B-6D5DDCD9B4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ED14A00-9E89-0CC8-8828-B893A37BAB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C5EB-E99E-48E7-806C-566BBE26CF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4030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17CAB8-FF00-664C-D0EF-E275DC0C16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608CA1-543A-A8D8-474F-24775BF44C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14E6F67-7158-DA25-6C72-868ABA8230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635153-7B90-2034-FE90-740362272D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85B51-CDF6-44DB-A5B5-27361F306A01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44DFCA-4B18-8EC5-0687-D1F52A23BF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59E029-7110-444B-E1D1-D32460910E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C5EB-E99E-48E7-806C-566BBE26CF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6050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7820F7-937D-22D9-4903-1EB77F9A46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DA02833-CD20-949D-4C45-EE3D47D4FC7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26F6E6-090E-409A-B1B3-1414795107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E0A459-5582-FBE1-F41B-E5466D336B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85B51-CDF6-44DB-A5B5-27361F306A01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0AB0E2-E483-C377-9B4B-867121C652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6CD500-6F1F-2ABF-ED4D-190B3FC0A5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C5EB-E99E-48E7-806C-566BBE26CF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208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85E0099-93E9-6CC0-2A78-1E1994FF9F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BD39D6-67EA-2436-DCB4-922B3545D4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DD2BCD-2B2B-727A-46F4-CF0B2A3D5C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1C85B51-CDF6-44DB-A5B5-27361F306A01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B2AD47-3AF6-A433-DD83-BCEDB0F0D2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F87BE8-6790-40CF-E12A-CAE1ABED5F3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638C5EB-E99E-48E7-806C-566BBE26CF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124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A3A8530-2658-AB70-AF5E-0E266A11CEA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1" t="10939" b="19692"/>
          <a:stretch/>
        </p:blipFill>
        <p:spPr bwMode="auto">
          <a:xfrm>
            <a:off x="1429852" y="643466"/>
            <a:ext cx="9332296" cy="5571067"/>
          </a:xfrm>
          <a:prstGeom prst="rect">
            <a:avLst/>
          </a:prstGeom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ABC19D4-6222-0C35-27AF-DA1CA959CAE0}"/>
              </a:ext>
            </a:extLst>
          </p:cNvPr>
          <p:cNvSpPr txBox="1"/>
          <p:nvPr/>
        </p:nvSpPr>
        <p:spPr>
          <a:xfrm>
            <a:off x="171449" y="6319308"/>
            <a:ext cx="11001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1. </a:t>
            </a:r>
            <a:r>
              <a:rPr lang="en-US" dirty="0"/>
              <a:t>Clinical course for Patient 1 from atrial arrhythmia diagnosis until present day  </a:t>
            </a:r>
          </a:p>
        </p:txBody>
      </p:sp>
    </p:spTree>
    <p:extLst>
      <p:ext uri="{BB962C8B-B14F-4D97-AF65-F5344CB8AC3E}">
        <p14:creationId xmlns:p14="http://schemas.microsoft.com/office/powerpoint/2010/main" val="26334776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991DD19-3F66-799C-EE62-08A24EB29B5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81" r="41026" b="28801"/>
          <a:stretch/>
        </p:blipFill>
        <p:spPr bwMode="auto">
          <a:xfrm>
            <a:off x="2623020" y="643466"/>
            <a:ext cx="6945960" cy="5571067"/>
          </a:xfrm>
          <a:prstGeom prst="rect">
            <a:avLst/>
          </a:prstGeom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3BA6AC9-5931-7076-7168-31FB794B2C9D}"/>
              </a:ext>
            </a:extLst>
          </p:cNvPr>
          <p:cNvSpPr txBox="1"/>
          <p:nvPr/>
        </p:nvSpPr>
        <p:spPr>
          <a:xfrm>
            <a:off x="238123" y="6319308"/>
            <a:ext cx="101727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2. </a:t>
            </a:r>
            <a:r>
              <a:rPr lang="en-US" dirty="0"/>
              <a:t>Clinical course for Patient 2 from atrial arrhythmia diagnosis until death </a:t>
            </a:r>
          </a:p>
        </p:txBody>
      </p:sp>
    </p:spTree>
    <p:extLst>
      <p:ext uri="{BB962C8B-B14F-4D97-AF65-F5344CB8AC3E}">
        <p14:creationId xmlns:p14="http://schemas.microsoft.com/office/powerpoint/2010/main" val="22819111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23F2A2F-B3DB-76A2-3718-E29A9213212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86" t="14271" r="32167" b="32343"/>
          <a:stretch/>
        </p:blipFill>
        <p:spPr bwMode="auto">
          <a:xfrm>
            <a:off x="2241195" y="643466"/>
            <a:ext cx="7709609" cy="5571067"/>
          </a:xfrm>
          <a:prstGeom prst="rect">
            <a:avLst/>
          </a:prstGeom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26805C7-9C3F-4274-D3F5-65313C612D70}"/>
              </a:ext>
            </a:extLst>
          </p:cNvPr>
          <p:cNvSpPr txBox="1"/>
          <p:nvPr/>
        </p:nvSpPr>
        <p:spPr>
          <a:xfrm>
            <a:off x="238123" y="6319308"/>
            <a:ext cx="11039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3. </a:t>
            </a:r>
            <a:r>
              <a:rPr lang="en-US" dirty="0"/>
              <a:t>Clinical course for Patient 3 from atrial arrhythmia diagnosis until present day </a:t>
            </a:r>
          </a:p>
        </p:txBody>
      </p:sp>
    </p:spTree>
    <p:extLst>
      <p:ext uri="{BB962C8B-B14F-4D97-AF65-F5344CB8AC3E}">
        <p14:creationId xmlns:p14="http://schemas.microsoft.com/office/powerpoint/2010/main" val="17950162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DB262F6-7067-CDEB-DE9E-D7F0252340D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273" b="18553"/>
          <a:stretch/>
        </p:blipFill>
        <p:spPr bwMode="auto">
          <a:xfrm>
            <a:off x="643467" y="685063"/>
            <a:ext cx="10905066" cy="5487872"/>
          </a:xfrm>
          <a:prstGeom prst="rect">
            <a:avLst/>
          </a:prstGeom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121BC9D-9093-EB1A-A66B-773E65A85045}"/>
              </a:ext>
            </a:extLst>
          </p:cNvPr>
          <p:cNvSpPr txBox="1"/>
          <p:nvPr/>
        </p:nvSpPr>
        <p:spPr>
          <a:xfrm>
            <a:off x="171449" y="6319308"/>
            <a:ext cx="11001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4. </a:t>
            </a:r>
            <a:r>
              <a:rPr lang="en-US" dirty="0"/>
              <a:t>Clinical course for Patient 4 from atrial arrhythmia diagnosis until present day  </a:t>
            </a:r>
          </a:p>
        </p:txBody>
      </p:sp>
    </p:spTree>
    <p:extLst>
      <p:ext uri="{BB962C8B-B14F-4D97-AF65-F5344CB8AC3E}">
        <p14:creationId xmlns:p14="http://schemas.microsoft.com/office/powerpoint/2010/main" val="40404822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5749D13-ECB2-1E6B-C3B2-A8C36FBC0F8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" t="8136" r="54544" b="30070"/>
          <a:stretch/>
        </p:blipFill>
        <p:spPr bwMode="auto">
          <a:xfrm>
            <a:off x="3194538" y="643466"/>
            <a:ext cx="5802924" cy="5571067"/>
          </a:xfrm>
          <a:prstGeom prst="rect">
            <a:avLst/>
          </a:prstGeom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404D6EA-C654-FD95-205E-AF834CADE90E}"/>
              </a:ext>
            </a:extLst>
          </p:cNvPr>
          <p:cNvSpPr txBox="1"/>
          <p:nvPr/>
        </p:nvSpPr>
        <p:spPr>
          <a:xfrm>
            <a:off x="171449" y="6319308"/>
            <a:ext cx="11001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5. </a:t>
            </a:r>
            <a:r>
              <a:rPr lang="en-US" dirty="0"/>
              <a:t>Clinical course for Patient 5 from atrial arrhythmia diagnosis until death</a:t>
            </a:r>
          </a:p>
        </p:txBody>
      </p:sp>
    </p:spTree>
    <p:extLst>
      <p:ext uri="{BB962C8B-B14F-4D97-AF65-F5344CB8AC3E}">
        <p14:creationId xmlns:p14="http://schemas.microsoft.com/office/powerpoint/2010/main" val="3122624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78</Words>
  <Application>Microsoft Office PowerPoint</Application>
  <PresentationFormat>Widescreen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einer, Eleanor</dc:creator>
  <cp:lastModifiedBy>Greiner, Eleanor</cp:lastModifiedBy>
  <cp:revision>1</cp:revision>
  <dcterms:created xsi:type="dcterms:W3CDTF">2024-05-22T21:09:20Z</dcterms:created>
  <dcterms:modified xsi:type="dcterms:W3CDTF">2024-05-22T21:19:54Z</dcterms:modified>
</cp:coreProperties>
</file>